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1" r:id="rId5"/>
    <p:sldId id="262" r:id="rId6"/>
    <p:sldId id="26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5096B0-3F26-478F-ABCE-233187B7A7B5}" v="115" dt="2020-10-21T11:46:11.7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42" d="100"/>
          <a:sy n="142" d="100"/>
        </p:scale>
        <p:origin x="900" y="-39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dhisattwa Banerjee" userId="94d1fc75-cd7b-431b-b343-58759385d710" providerId="ADAL" clId="{965096B0-3F26-478F-ABCE-233187B7A7B5}"/>
    <pc:docChg chg="undo custSel addSld delSld modSld sldOrd">
      <pc:chgData name="Bodhisattwa Banerjee" userId="94d1fc75-cd7b-431b-b343-58759385d710" providerId="ADAL" clId="{965096B0-3F26-478F-ABCE-233187B7A7B5}" dt="2020-10-21T11:46:15.840" v="593" actId="1076"/>
      <pc:docMkLst>
        <pc:docMk/>
      </pc:docMkLst>
      <pc:sldChg chg="del">
        <pc:chgData name="Bodhisattwa Banerjee" userId="94d1fc75-cd7b-431b-b343-58759385d710" providerId="ADAL" clId="{965096B0-3F26-478F-ABCE-233187B7A7B5}" dt="2020-10-12T08:23:14.015" v="0" actId="2696"/>
        <pc:sldMkLst>
          <pc:docMk/>
          <pc:sldMk cId="1769123648" sldId="257"/>
        </pc:sldMkLst>
      </pc:sldChg>
      <pc:sldChg chg="del">
        <pc:chgData name="Bodhisattwa Banerjee" userId="94d1fc75-cd7b-431b-b343-58759385d710" providerId="ADAL" clId="{965096B0-3F26-478F-ABCE-233187B7A7B5}" dt="2020-10-20T07:41:49.108" v="4" actId="2696"/>
        <pc:sldMkLst>
          <pc:docMk/>
          <pc:sldMk cId="1181695407" sldId="258"/>
        </pc:sldMkLst>
      </pc:sldChg>
      <pc:sldChg chg="addSp delSp modSp add del ord">
        <pc:chgData name="Bodhisattwa Banerjee" userId="94d1fc75-cd7b-431b-b343-58759385d710" providerId="ADAL" clId="{965096B0-3F26-478F-ABCE-233187B7A7B5}" dt="2020-10-21T10:24:23.123" v="530" actId="2696"/>
        <pc:sldMkLst>
          <pc:docMk/>
          <pc:sldMk cId="1495687033" sldId="259"/>
        </pc:sldMkLst>
        <pc:spChg chg="add del mod">
          <ac:chgData name="Bodhisattwa Banerjee" userId="94d1fc75-cd7b-431b-b343-58759385d710" providerId="ADAL" clId="{965096B0-3F26-478F-ABCE-233187B7A7B5}" dt="2020-10-21T10:21:39.040" v="469"/>
          <ac:spMkLst>
            <pc:docMk/>
            <pc:sldMk cId="1495687033" sldId="259"/>
            <ac:spMk id="13" creationId="{3138F371-561A-4329-B1C8-992A7F8F5C84}"/>
          </ac:spMkLst>
        </pc:spChg>
        <pc:grpChg chg="add mod">
          <ac:chgData name="Bodhisattwa Banerjee" userId="94d1fc75-cd7b-431b-b343-58759385d710" providerId="ADAL" clId="{965096B0-3F26-478F-ABCE-233187B7A7B5}" dt="2020-10-19T10:04:00.466" v="3" actId="1076"/>
          <ac:grpSpMkLst>
            <pc:docMk/>
            <pc:sldMk cId="1495687033" sldId="259"/>
            <ac:grpSpMk id="2" creationId="{038ADD48-0CE2-40E2-976A-17FED639F078}"/>
          </ac:grpSpMkLst>
        </pc:grpChg>
      </pc:sldChg>
      <pc:sldChg chg="addSp modSp add mod ord">
        <pc:chgData name="Bodhisattwa Banerjee" userId="94d1fc75-cd7b-431b-b343-58759385d710" providerId="ADAL" clId="{965096B0-3F26-478F-ABCE-233187B7A7B5}" dt="2020-10-21T11:44:06.975" v="567" actId="20577"/>
        <pc:sldMkLst>
          <pc:docMk/>
          <pc:sldMk cId="2444185793" sldId="260"/>
        </pc:sldMkLst>
        <pc:spChg chg="add mod">
          <ac:chgData name="Bodhisattwa Banerjee" userId="94d1fc75-cd7b-431b-b343-58759385d710" providerId="ADAL" clId="{965096B0-3F26-478F-ABCE-233187B7A7B5}" dt="2020-10-21T10:06:54.963" v="74" actId="1076"/>
          <ac:spMkLst>
            <pc:docMk/>
            <pc:sldMk cId="2444185793" sldId="260"/>
            <ac:spMk id="5" creationId="{BE5DA721-7950-42B6-9F85-3E491C42BD75}"/>
          </ac:spMkLst>
        </pc:spChg>
        <pc:spChg chg="add mod">
          <ac:chgData name="Bodhisattwa Banerjee" userId="94d1fc75-cd7b-431b-b343-58759385d710" providerId="ADAL" clId="{965096B0-3F26-478F-ABCE-233187B7A7B5}" dt="2020-10-21T10:07:24.462" v="86" actId="1035"/>
          <ac:spMkLst>
            <pc:docMk/>
            <pc:sldMk cId="2444185793" sldId="260"/>
            <ac:spMk id="6" creationId="{E6590D5C-C0ED-4669-89F5-5CA0D10D2AD4}"/>
          </ac:spMkLst>
        </pc:spChg>
        <pc:spChg chg="add mod">
          <ac:chgData name="Bodhisattwa Banerjee" userId="94d1fc75-cd7b-431b-b343-58759385d710" providerId="ADAL" clId="{965096B0-3F26-478F-ABCE-233187B7A7B5}" dt="2020-10-21T10:07:31.500" v="101" actId="1035"/>
          <ac:spMkLst>
            <pc:docMk/>
            <pc:sldMk cId="2444185793" sldId="260"/>
            <ac:spMk id="7" creationId="{371350F8-5E20-4158-BE41-FE0E4FF267A3}"/>
          </ac:spMkLst>
        </pc:spChg>
        <pc:spChg chg="add mod">
          <ac:chgData name="Bodhisattwa Banerjee" userId="94d1fc75-cd7b-431b-b343-58759385d710" providerId="ADAL" clId="{965096B0-3F26-478F-ABCE-233187B7A7B5}" dt="2020-10-21T11:44:06.975" v="567" actId="20577"/>
          <ac:spMkLst>
            <pc:docMk/>
            <pc:sldMk cId="2444185793" sldId="260"/>
            <ac:spMk id="8" creationId="{CC283A7E-5D23-49C2-9743-46703BFE469D}"/>
          </ac:spMkLst>
        </pc:spChg>
        <pc:graphicFrameChg chg="add mod">
          <ac:chgData name="Bodhisattwa Banerjee" userId="94d1fc75-cd7b-431b-b343-58759385d710" providerId="ADAL" clId="{965096B0-3F26-478F-ABCE-233187B7A7B5}" dt="2020-10-21T10:13:16.225" v="316" actId="14100"/>
          <ac:graphicFrameMkLst>
            <pc:docMk/>
            <pc:sldMk cId="2444185793" sldId="260"/>
            <ac:graphicFrameMk id="2" creationId="{AA201CF5-4FB6-4CCC-9A7A-4EC91146EAAB}"/>
          </ac:graphicFrameMkLst>
        </pc:graphicFrameChg>
        <pc:graphicFrameChg chg="add mod">
          <ac:chgData name="Bodhisattwa Banerjee" userId="94d1fc75-cd7b-431b-b343-58759385d710" providerId="ADAL" clId="{965096B0-3F26-478F-ABCE-233187B7A7B5}" dt="2020-10-21T10:07:24.462" v="86" actId="1035"/>
          <ac:graphicFrameMkLst>
            <pc:docMk/>
            <pc:sldMk cId="2444185793" sldId="260"/>
            <ac:graphicFrameMk id="3" creationId="{328ADCBD-7B35-4A2E-9B10-B25867402C12}"/>
          </ac:graphicFrameMkLst>
        </pc:graphicFrameChg>
        <pc:graphicFrameChg chg="add mod">
          <ac:chgData name="Bodhisattwa Banerjee" userId="94d1fc75-cd7b-431b-b343-58759385d710" providerId="ADAL" clId="{965096B0-3F26-478F-ABCE-233187B7A7B5}" dt="2020-10-21T10:13:23.346" v="317" actId="14100"/>
          <ac:graphicFrameMkLst>
            <pc:docMk/>
            <pc:sldMk cId="2444185793" sldId="260"/>
            <ac:graphicFrameMk id="4" creationId="{DCCBDEF8-2E2B-4E38-A2C6-D20820DCECF8}"/>
          </ac:graphicFrameMkLst>
        </pc:graphicFrameChg>
      </pc:sldChg>
      <pc:sldChg chg="addSp delSp modSp add">
        <pc:chgData name="Bodhisattwa Banerjee" userId="94d1fc75-cd7b-431b-b343-58759385d710" providerId="ADAL" clId="{965096B0-3F26-478F-ABCE-233187B7A7B5}" dt="2020-10-21T11:18:48.800" v="556" actId="6549"/>
        <pc:sldMkLst>
          <pc:docMk/>
          <pc:sldMk cId="1023458860" sldId="261"/>
        </pc:sldMkLst>
        <pc:spChg chg="add mod">
          <ac:chgData name="Bodhisattwa Banerjee" userId="94d1fc75-cd7b-431b-b343-58759385d710" providerId="ADAL" clId="{965096B0-3F26-478F-ABCE-233187B7A7B5}" dt="2020-10-21T11:18:48.800" v="556" actId="6549"/>
          <ac:spMkLst>
            <pc:docMk/>
            <pc:sldMk cId="1023458860" sldId="261"/>
            <ac:spMk id="3" creationId="{9B3D9467-C61D-4514-BD42-4537DB2B75D7}"/>
          </ac:spMkLst>
        </pc:spChg>
        <pc:spChg chg="add del">
          <ac:chgData name="Bodhisattwa Banerjee" userId="94d1fc75-cd7b-431b-b343-58759385d710" providerId="ADAL" clId="{965096B0-3F26-478F-ABCE-233187B7A7B5}" dt="2020-10-21T11:18:37.409" v="554"/>
          <ac:spMkLst>
            <pc:docMk/>
            <pc:sldMk cId="1023458860" sldId="261"/>
            <ac:spMk id="4" creationId="{AAD7597F-430E-4B90-B610-237433CC37F6}"/>
          </ac:spMkLst>
        </pc:spChg>
        <pc:picChg chg="add mod">
          <ac:chgData name="Bodhisattwa Banerjee" userId="94d1fc75-cd7b-431b-b343-58759385d710" providerId="ADAL" clId="{965096B0-3F26-478F-ABCE-233187B7A7B5}" dt="2020-10-21T10:54:49.152" v="544" actId="1076"/>
          <ac:picMkLst>
            <pc:docMk/>
            <pc:sldMk cId="1023458860" sldId="261"/>
            <ac:picMk id="2" creationId="{5C704080-2D6D-4D4A-BCE4-60979369D6DC}"/>
          </ac:picMkLst>
        </pc:picChg>
      </pc:sldChg>
      <pc:sldChg chg="addSp delSp modSp add del">
        <pc:chgData name="Bodhisattwa Banerjee" userId="94d1fc75-cd7b-431b-b343-58759385d710" providerId="ADAL" clId="{965096B0-3F26-478F-ABCE-233187B7A7B5}" dt="2020-10-21T10:34:16.752" v="533" actId="2696"/>
        <pc:sldMkLst>
          <pc:docMk/>
          <pc:sldMk cId="2614745911" sldId="261"/>
        </pc:sldMkLst>
        <pc:spChg chg="add mod">
          <ac:chgData name="Bodhisattwa Banerjee" userId="94d1fc75-cd7b-431b-b343-58759385d710" providerId="ADAL" clId="{965096B0-3F26-478F-ABCE-233187B7A7B5}" dt="2020-10-21T10:24:17.882" v="529" actId="1076"/>
          <ac:spMkLst>
            <pc:docMk/>
            <pc:sldMk cId="2614745911" sldId="261"/>
            <ac:spMk id="5" creationId="{A156EF59-E023-4D26-9D7D-33F467B67B46}"/>
          </ac:spMkLst>
        </pc:spChg>
        <pc:spChg chg="add mod">
          <ac:chgData name="Bodhisattwa Banerjee" userId="94d1fc75-cd7b-431b-b343-58759385d710" providerId="ADAL" clId="{965096B0-3F26-478F-ABCE-233187B7A7B5}" dt="2020-10-21T10:24:15.522" v="528" actId="1076"/>
          <ac:spMkLst>
            <pc:docMk/>
            <pc:sldMk cId="2614745911" sldId="261"/>
            <ac:spMk id="6" creationId="{9711E029-D19A-4F92-97E7-33FC646D41B0}"/>
          </ac:spMkLst>
        </pc:spChg>
        <pc:spChg chg="add mod">
          <ac:chgData name="Bodhisattwa Banerjee" userId="94d1fc75-cd7b-431b-b343-58759385d710" providerId="ADAL" clId="{965096B0-3F26-478F-ABCE-233187B7A7B5}" dt="2020-10-21T10:24:15.522" v="528" actId="1076"/>
          <ac:spMkLst>
            <pc:docMk/>
            <pc:sldMk cId="2614745911" sldId="261"/>
            <ac:spMk id="7" creationId="{229ABCEB-C248-4F2B-A713-E437E9A12F1B}"/>
          </ac:spMkLst>
        </pc:spChg>
        <pc:picChg chg="add del mod">
          <ac:chgData name="Bodhisattwa Banerjee" userId="94d1fc75-cd7b-431b-b343-58759385d710" providerId="ADAL" clId="{965096B0-3F26-478F-ABCE-233187B7A7B5}" dt="2020-10-21T10:21:14.569" v="465" actId="478"/>
          <ac:picMkLst>
            <pc:docMk/>
            <pc:sldMk cId="2614745911" sldId="261"/>
            <ac:picMk id="3" creationId="{FF5C6F4B-550C-4366-B7C6-5591EEF39A25}"/>
          </ac:picMkLst>
        </pc:picChg>
        <pc:picChg chg="add mod">
          <ac:chgData name="Bodhisattwa Banerjee" userId="94d1fc75-cd7b-431b-b343-58759385d710" providerId="ADAL" clId="{965096B0-3F26-478F-ABCE-233187B7A7B5}" dt="2020-10-21T10:24:49.666" v="532" actId="1076"/>
          <ac:picMkLst>
            <pc:docMk/>
            <pc:sldMk cId="2614745911" sldId="261"/>
            <ac:picMk id="1026" creationId="{F13C3FAE-39CA-4D8D-952B-B7C66984D31C}"/>
          </ac:picMkLst>
        </pc:picChg>
      </pc:sldChg>
      <pc:sldChg chg="addSp modSp add">
        <pc:chgData name="Bodhisattwa Banerjee" userId="94d1fc75-cd7b-431b-b343-58759385d710" providerId="ADAL" clId="{965096B0-3F26-478F-ABCE-233187B7A7B5}" dt="2020-10-21T11:46:15.840" v="593" actId="1076"/>
        <pc:sldMkLst>
          <pc:docMk/>
          <pc:sldMk cId="2734186185" sldId="262"/>
        </pc:sldMkLst>
        <pc:spChg chg="add mod">
          <ac:chgData name="Bodhisattwa Banerjee" userId="94d1fc75-cd7b-431b-b343-58759385d710" providerId="ADAL" clId="{965096B0-3F26-478F-ABCE-233187B7A7B5}" dt="2020-10-21T11:46:15.840" v="593" actId="1076"/>
          <ac:spMkLst>
            <pc:docMk/>
            <pc:sldMk cId="2734186185" sldId="262"/>
            <ac:spMk id="4" creationId="{CF6E4DE0-FB8B-43BE-B350-FEBD46138B12}"/>
          </ac:spMkLst>
        </pc:spChg>
        <pc:spChg chg="add">
          <ac:chgData name="Bodhisattwa Banerjee" userId="94d1fc75-cd7b-431b-b343-58759385d710" providerId="ADAL" clId="{965096B0-3F26-478F-ABCE-233187B7A7B5}" dt="2020-10-21T11:45:25.045" v="582"/>
          <ac:spMkLst>
            <pc:docMk/>
            <pc:sldMk cId="2734186185" sldId="262"/>
            <ac:spMk id="7" creationId="{773D33FD-34BC-4EC9-86FF-C0C4C14A298C}"/>
          </ac:spMkLst>
        </pc:spChg>
        <pc:spChg chg="add mod">
          <ac:chgData name="Bodhisattwa Banerjee" userId="94d1fc75-cd7b-431b-b343-58759385d710" providerId="ADAL" clId="{965096B0-3F26-478F-ABCE-233187B7A7B5}" dt="2020-10-21T11:45:35.878" v="586" actId="20577"/>
          <ac:spMkLst>
            <pc:docMk/>
            <pc:sldMk cId="2734186185" sldId="262"/>
            <ac:spMk id="8" creationId="{7DB4809A-0857-4AEB-973D-BB0FAE0222D3}"/>
          </ac:spMkLst>
        </pc:spChg>
        <pc:picChg chg="add mod modCrop">
          <ac:chgData name="Bodhisattwa Banerjee" userId="94d1fc75-cd7b-431b-b343-58759385d710" providerId="ADAL" clId="{965096B0-3F26-478F-ABCE-233187B7A7B5}" dt="2020-10-21T11:45:12.493" v="580" actId="732"/>
          <ac:picMkLst>
            <pc:docMk/>
            <pc:sldMk cId="2734186185" sldId="262"/>
            <ac:picMk id="3" creationId="{A01CCC50-0D86-405D-8082-BED89F37B2BF}"/>
          </ac:picMkLst>
        </pc:picChg>
        <pc:picChg chg="add mod modCrop">
          <ac:chgData name="Bodhisattwa Banerjee" userId="94d1fc75-cd7b-431b-b343-58759385d710" providerId="ADAL" clId="{965096B0-3F26-478F-ABCE-233187B7A7B5}" dt="2020-10-21T11:45:16.181" v="581" actId="1076"/>
          <ac:picMkLst>
            <pc:docMk/>
            <pc:sldMk cId="2734186185" sldId="262"/>
            <ac:picMk id="6" creationId="{887E902D-895C-4AE0-8116-459D91437903}"/>
          </ac:picMkLst>
        </pc:picChg>
      </pc:sldChg>
    </pc:docChg>
  </pc:docChgLst>
  <pc:docChgLst>
    <pc:chgData name="Bodhisattwa Banerjee" userId="94d1fc75-cd7b-431b-b343-58759385d710" providerId="ADAL" clId="{16188325-C2D0-4688-B541-A3C2FE589A9D}"/>
    <pc:docChg chg="addSld modSld">
      <pc:chgData name="Bodhisattwa Banerjee" userId="94d1fc75-cd7b-431b-b343-58759385d710" providerId="ADAL" clId="{16188325-C2D0-4688-B541-A3C2FE589A9D}" dt="2020-10-05T08:36:33.042" v="21" actId="1076"/>
      <pc:docMkLst>
        <pc:docMk/>
      </pc:docMkLst>
      <pc:sldChg chg="addSp modSp add">
        <pc:chgData name="Bodhisattwa Banerjee" userId="94d1fc75-cd7b-431b-b343-58759385d710" providerId="ADAL" clId="{16188325-C2D0-4688-B541-A3C2FE589A9D}" dt="2020-10-05T08:36:33.042" v="21" actId="1076"/>
        <pc:sldMkLst>
          <pc:docMk/>
          <pc:sldMk cId="1181695407" sldId="258"/>
        </pc:sldMkLst>
        <pc:spChg chg="add mod">
          <ac:chgData name="Bodhisattwa Banerjee" userId="94d1fc75-cd7b-431b-b343-58759385d710" providerId="ADAL" clId="{16188325-C2D0-4688-B541-A3C2FE589A9D}" dt="2020-10-05T08:32:35.928" v="9" actId="1076"/>
          <ac:spMkLst>
            <pc:docMk/>
            <pc:sldMk cId="1181695407" sldId="258"/>
            <ac:spMk id="4" creationId="{912F349A-A4E9-435F-AA8D-EC836EA72230}"/>
          </ac:spMkLst>
        </pc:spChg>
        <pc:spChg chg="add mod">
          <ac:chgData name="Bodhisattwa Banerjee" userId="94d1fc75-cd7b-431b-b343-58759385d710" providerId="ADAL" clId="{16188325-C2D0-4688-B541-A3C2FE589A9D}" dt="2020-10-05T08:32:26.676" v="8" actId="20577"/>
          <ac:spMkLst>
            <pc:docMk/>
            <pc:sldMk cId="1181695407" sldId="258"/>
            <ac:spMk id="5" creationId="{8DB84655-9A0B-4537-B2CA-36E115306C9F}"/>
          </ac:spMkLst>
        </pc:spChg>
        <pc:picChg chg="add mod">
          <ac:chgData name="Bodhisattwa Banerjee" userId="94d1fc75-cd7b-431b-b343-58759385d710" providerId="ADAL" clId="{16188325-C2D0-4688-B541-A3C2FE589A9D}" dt="2020-10-05T08:31:20.891" v="2" actId="1076"/>
          <ac:picMkLst>
            <pc:docMk/>
            <pc:sldMk cId="1181695407" sldId="258"/>
            <ac:picMk id="2" creationId="{0BEBD9E3-5CA6-4087-80B6-571D28F48AD1}"/>
          </ac:picMkLst>
        </pc:picChg>
        <pc:picChg chg="add mod">
          <ac:chgData name="Bodhisattwa Banerjee" userId="94d1fc75-cd7b-431b-b343-58759385d710" providerId="ADAL" clId="{16188325-C2D0-4688-B541-A3C2FE589A9D}" dt="2020-10-05T08:36:27.345" v="20" actId="1076"/>
          <ac:picMkLst>
            <pc:docMk/>
            <pc:sldMk cId="1181695407" sldId="258"/>
            <ac:picMk id="3" creationId="{699D32BE-6FEF-47DC-82AC-830BFE2E400F}"/>
          </ac:picMkLst>
        </pc:picChg>
        <pc:picChg chg="add mod">
          <ac:chgData name="Bodhisattwa Banerjee" userId="94d1fc75-cd7b-431b-b343-58759385d710" providerId="ADAL" clId="{16188325-C2D0-4688-B541-A3C2FE589A9D}" dt="2020-10-05T08:36:33.042" v="21" actId="1076"/>
          <ac:picMkLst>
            <pc:docMk/>
            <pc:sldMk cId="1181695407" sldId="258"/>
            <ac:picMk id="1026" creationId="{0E03C79C-1408-4704-9B0E-803684B8BC1C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biu365-my.sharepoint.com/personal/banerjb_biu_ac_il/Documents/lncRNA%20paper/R1/Data/lnc_types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biu365-my.sharepoint.com/personal/banerjb_biu_ac_il/Documents/lncRNA%20paper/R1/Data/lnc_types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biu365-my.sharepoint.com/personal/banerjb_biu_ac_il/Documents/lncRNA%20paper/R1/Data/lnc_types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C$124</c:f>
              <c:strCache>
                <c:ptCount val="1"/>
                <c:pt idx="0">
                  <c:v>adj.Pv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125:$B$132</c:f>
              <c:strCache>
                <c:ptCount val="8"/>
                <c:pt idx="0">
                  <c:v>Alzheimer's disease</c:v>
                </c:pt>
                <c:pt idx="1">
                  <c:v>Type 2 diabetes mellitus</c:v>
                </c:pt>
                <c:pt idx="2">
                  <c:v>Acute myeloid leukemia</c:v>
                </c:pt>
                <c:pt idx="3">
                  <c:v>Myocardial infarction</c:v>
                </c:pt>
                <c:pt idx="4">
                  <c:v>Porencephaly</c:v>
                </c:pt>
                <c:pt idx="5">
                  <c:v>Obesity</c:v>
                </c:pt>
                <c:pt idx="6">
                  <c:v>Renal cell carcinoma</c:v>
                </c:pt>
                <c:pt idx="7">
                  <c:v>Idiopathic pulmonary fibrosis</c:v>
                </c:pt>
              </c:strCache>
            </c:strRef>
          </c:cat>
          <c:val>
            <c:numRef>
              <c:f>Sheet2!$C$125:$C$132</c:f>
              <c:numCache>
                <c:formatCode>General</c:formatCode>
                <c:ptCount val="8"/>
                <c:pt idx="0">
                  <c:v>6.73</c:v>
                </c:pt>
                <c:pt idx="1">
                  <c:v>5.5</c:v>
                </c:pt>
                <c:pt idx="2">
                  <c:v>5.4</c:v>
                </c:pt>
                <c:pt idx="3">
                  <c:v>5.3</c:v>
                </c:pt>
                <c:pt idx="4">
                  <c:v>4.976233867378923</c:v>
                </c:pt>
                <c:pt idx="5">
                  <c:v>4.976233867378923</c:v>
                </c:pt>
                <c:pt idx="6">
                  <c:v>4.976233867378923</c:v>
                </c:pt>
                <c:pt idx="7">
                  <c:v>4.9762338673789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87-48DE-9E9E-C04EF3F139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944344864"/>
        <c:axId val="846626096"/>
      </c:barChart>
      <c:catAx>
        <c:axId val="9443448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846626096"/>
        <c:crosses val="autoZero"/>
        <c:auto val="1"/>
        <c:lblAlgn val="ctr"/>
        <c:lblOffset val="100"/>
        <c:noMultiLvlLbl val="0"/>
      </c:catAx>
      <c:valAx>
        <c:axId val="846626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94434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C$140</c:f>
              <c:strCache>
                <c:ptCount val="1"/>
                <c:pt idx="0">
                  <c:v>adj.Pva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141:$B$146</c:f>
              <c:strCache>
                <c:ptCount val="6"/>
                <c:pt idx="0">
                  <c:v>Myocardial infarction</c:v>
                </c:pt>
                <c:pt idx="1">
                  <c:v>Atherosclerosis</c:v>
                </c:pt>
                <c:pt idx="2">
                  <c:v>Familial visceral amyloidosis</c:v>
                </c:pt>
                <c:pt idx="3">
                  <c:v>Complement component 7 deficiency</c:v>
                </c:pt>
                <c:pt idx="4">
                  <c:v>Congestive heart failure</c:v>
                </c:pt>
                <c:pt idx="5">
                  <c:v>Type 2 diabetes mellitus</c:v>
                </c:pt>
              </c:strCache>
            </c:strRef>
          </c:cat>
          <c:val>
            <c:numRef>
              <c:f>Sheet2!$C$141:$C$146</c:f>
              <c:numCache>
                <c:formatCode>General</c:formatCode>
                <c:ptCount val="6"/>
                <c:pt idx="0">
                  <c:v>9.1150301921718579</c:v>
                </c:pt>
                <c:pt idx="1">
                  <c:v>6.2149999999999999</c:v>
                </c:pt>
                <c:pt idx="2">
                  <c:v>6.2140000000000004</c:v>
                </c:pt>
                <c:pt idx="3">
                  <c:v>5.952243833954701</c:v>
                </c:pt>
                <c:pt idx="4">
                  <c:v>5.9522438339547001</c:v>
                </c:pt>
                <c:pt idx="5">
                  <c:v>5.2590966533947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AD-45CF-8EA5-FECF6C9D5F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019425456"/>
        <c:axId val="956555200"/>
      </c:barChart>
      <c:catAx>
        <c:axId val="1019425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956555200"/>
        <c:crosses val="autoZero"/>
        <c:auto val="1"/>
        <c:lblAlgn val="ctr"/>
        <c:lblOffset val="100"/>
        <c:noMultiLvlLbl val="0"/>
      </c:catAx>
      <c:valAx>
        <c:axId val="956555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1019425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C$158</c:f>
              <c:strCache>
                <c:ptCount val="1"/>
                <c:pt idx="0">
                  <c:v>adj.Pva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B$159:$B$165</c:f>
              <c:strCache>
                <c:ptCount val="7"/>
                <c:pt idx="0">
                  <c:v>Alzheimer's disease</c:v>
                </c:pt>
                <c:pt idx="1">
                  <c:v>Hypertension</c:v>
                </c:pt>
                <c:pt idx="2">
                  <c:v>Squamous cell carcinoma</c:v>
                </c:pt>
                <c:pt idx="3">
                  <c:v>Pre-eclampsia</c:v>
                </c:pt>
                <c:pt idx="4">
                  <c:v>Heart disease</c:v>
                </c:pt>
                <c:pt idx="5">
                  <c:v>Type 2 diabetes mellitus</c:v>
                </c:pt>
                <c:pt idx="6">
                  <c:v>Myocardial infarction</c:v>
                </c:pt>
              </c:strCache>
            </c:strRef>
          </c:cat>
          <c:val>
            <c:numRef>
              <c:f>Sheet2!$C$159:$C$165</c:f>
              <c:numCache>
                <c:formatCode>General</c:formatCode>
                <c:ptCount val="7"/>
                <c:pt idx="0">
                  <c:v>4.96</c:v>
                </c:pt>
                <c:pt idx="1">
                  <c:v>4.9219880930827697</c:v>
                </c:pt>
                <c:pt idx="2">
                  <c:v>4.82</c:v>
                </c:pt>
                <c:pt idx="3">
                  <c:v>4.656463480375642</c:v>
                </c:pt>
                <c:pt idx="4">
                  <c:v>4.6500000000000004</c:v>
                </c:pt>
                <c:pt idx="5">
                  <c:v>4.656463480375642</c:v>
                </c:pt>
                <c:pt idx="6">
                  <c:v>4.6564634803756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5C-496A-BF51-7C53C26305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024964320"/>
        <c:axId val="956558112"/>
      </c:barChart>
      <c:catAx>
        <c:axId val="1024964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956558112"/>
        <c:crosses val="autoZero"/>
        <c:auto val="1"/>
        <c:lblAlgn val="ctr"/>
        <c:lblOffset val="100"/>
        <c:noMultiLvlLbl val="0"/>
      </c:catAx>
      <c:valAx>
        <c:axId val="956558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IL"/>
          </a:p>
        </c:txPr>
        <c:crossAx val="1024964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206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285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649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56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714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24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406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80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415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495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712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E58C1-AEC1-4936-AAE6-5435875C62C6}" type="datetimeFigureOut">
              <a:rPr lang="en-US" smtClean="0"/>
              <a:t>10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0E07A-D86F-405B-B701-CF1F545E6B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044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C704080-2D6D-4D4A-BCE4-60979369D6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9" t="2299" r="6903" b="3073"/>
          <a:stretch/>
        </p:blipFill>
        <p:spPr>
          <a:xfrm>
            <a:off x="1091393" y="768329"/>
            <a:ext cx="4675214" cy="46937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B3D9467-C61D-4514-BD42-4537DB2B75D7}"/>
              </a:ext>
            </a:extLst>
          </p:cNvPr>
          <p:cNvSpPr txBox="1"/>
          <p:nvPr/>
        </p:nvSpPr>
        <p:spPr>
          <a:xfrm flipH="1">
            <a:off x="335853" y="7108635"/>
            <a:ext cx="6186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an overlap of novel lncRNAs in three different brain regions. Fb: forebrain, Mb: midbrain, Hb: hindbrain.</a:t>
            </a:r>
          </a:p>
        </p:txBody>
      </p:sp>
    </p:spTree>
    <p:extLst>
      <p:ext uri="{BB962C8B-B14F-4D97-AF65-F5344CB8AC3E}">
        <p14:creationId xmlns:p14="http://schemas.microsoft.com/office/powerpoint/2010/main" val="10234588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, letter&#10;&#10;Description automatically generated">
            <a:extLst>
              <a:ext uri="{FF2B5EF4-FFF2-40B4-BE49-F238E27FC236}">
                <a16:creationId xmlns:a16="http://schemas.microsoft.com/office/drawing/2014/main" id="{A01CCC50-0D86-405D-8082-BED89F37B2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51" r="38995" b="2723"/>
          <a:stretch/>
        </p:blipFill>
        <p:spPr>
          <a:xfrm>
            <a:off x="736548" y="196363"/>
            <a:ext cx="4183693" cy="37167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6E4DE0-FB8B-43BE-B350-FEBD46138B12}"/>
              </a:ext>
            </a:extLst>
          </p:cNvPr>
          <p:cNvSpPr txBox="1"/>
          <p:nvPr/>
        </p:nvSpPr>
        <p:spPr>
          <a:xfrm flipH="1">
            <a:off x="277317" y="7833151"/>
            <a:ext cx="61862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ways with many shared genes are clustered together. Bigger dots indicate more significant P-values. (A) Enrichment using GO Biological process. (B) Enrichment using KEGG pathway.</a:t>
            </a:r>
          </a:p>
        </p:txBody>
      </p:sp>
      <p:pic>
        <p:nvPicPr>
          <p:cNvPr id="6" name="Picture 5" descr="A close up of a tree&#10;&#10;Description automatically generated">
            <a:extLst>
              <a:ext uri="{FF2B5EF4-FFF2-40B4-BE49-F238E27FC236}">
                <a16:creationId xmlns:a16="http://schemas.microsoft.com/office/drawing/2014/main" id="{887E902D-895C-4AE0-8116-459D9143790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18355" r="58530" b="14978"/>
          <a:stretch/>
        </p:blipFill>
        <p:spPr>
          <a:xfrm>
            <a:off x="605118" y="4262716"/>
            <a:ext cx="2702858" cy="260701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73D33FD-34BC-4EC9-86FF-C0C4C14A298C}"/>
              </a:ext>
            </a:extLst>
          </p:cNvPr>
          <p:cNvSpPr txBox="1"/>
          <p:nvPr/>
        </p:nvSpPr>
        <p:spPr>
          <a:xfrm flipH="1">
            <a:off x="210081" y="111690"/>
            <a:ext cx="33793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B4809A-0857-4AEB-973D-BB0FAE0222D3}"/>
              </a:ext>
            </a:extLst>
          </p:cNvPr>
          <p:cNvSpPr txBox="1"/>
          <p:nvPr/>
        </p:nvSpPr>
        <p:spPr>
          <a:xfrm flipH="1">
            <a:off x="210080" y="4183908"/>
            <a:ext cx="33793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34186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AA201CF5-4FB6-4CCC-9A7A-4EC91146EA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7111559"/>
              </p:ext>
            </p:extLst>
          </p:nvPr>
        </p:nvGraphicFramePr>
        <p:xfrm>
          <a:off x="543316" y="111690"/>
          <a:ext cx="5673240" cy="2856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328ADCBD-7B35-4A2E-9B10-B25867402C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3868813"/>
              </p:ext>
            </p:extLst>
          </p:nvPr>
        </p:nvGraphicFramePr>
        <p:xfrm>
          <a:off x="90810" y="2880986"/>
          <a:ext cx="6186294" cy="2856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CCBDEF8-2E2B-4E38-A2C6-D20820DCEC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4310783"/>
              </p:ext>
            </p:extLst>
          </p:nvPr>
        </p:nvGraphicFramePr>
        <p:xfrm>
          <a:off x="843157" y="5675334"/>
          <a:ext cx="5510944" cy="2856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E5DA721-7950-42B6-9F85-3E491C42BD75}"/>
              </a:ext>
            </a:extLst>
          </p:cNvPr>
          <p:cNvSpPr txBox="1"/>
          <p:nvPr/>
        </p:nvSpPr>
        <p:spPr>
          <a:xfrm flipH="1">
            <a:off x="210081" y="111690"/>
            <a:ext cx="33793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590D5C-C0ED-4669-89F5-5CA0D10D2AD4}"/>
              </a:ext>
            </a:extLst>
          </p:cNvPr>
          <p:cNvSpPr txBox="1"/>
          <p:nvPr/>
        </p:nvSpPr>
        <p:spPr>
          <a:xfrm flipH="1">
            <a:off x="167806" y="2880986"/>
            <a:ext cx="33793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1350F8-5E20-4158-BE41-FE0E4FF267A3}"/>
              </a:ext>
            </a:extLst>
          </p:cNvPr>
          <p:cNvSpPr txBox="1"/>
          <p:nvPr/>
        </p:nvSpPr>
        <p:spPr>
          <a:xfrm flipH="1">
            <a:off x="167807" y="5675334"/>
            <a:ext cx="33793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C283A7E-5D23-49C2-9743-46703BFE469D}"/>
              </a:ext>
            </a:extLst>
          </p:cNvPr>
          <p:cNvSpPr txBox="1"/>
          <p:nvPr/>
        </p:nvSpPr>
        <p:spPr>
          <a:xfrm flipH="1">
            <a:off x="210081" y="8949961"/>
            <a:ext cx="6186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ment of co-expression hub network genes using Disease.ZFIN database (A) Fb region (B) Mb region (C) Hb region</a:t>
            </a:r>
          </a:p>
        </p:txBody>
      </p:sp>
    </p:spTree>
    <p:extLst>
      <p:ext uri="{BB962C8B-B14F-4D97-AF65-F5344CB8AC3E}">
        <p14:creationId xmlns:p14="http://schemas.microsoft.com/office/powerpoint/2010/main" val="2444185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C3B29FB5C0B9348989210E6C8B190A2" ma:contentTypeVersion="8" ma:contentTypeDescription="Create a new document." ma:contentTypeScope="" ma:versionID="037daf9b7230545c375d533d20d01e66">
  <xsd:schema xmlns:xsd="http://www.w3.org/2001/XMLSchema" xmlns:xs="http://www.w3.org/2001/XMLSchema" xmlns:p="http://schemas.microsoft.com/office/2006/metadata/properties" xmlns:ns3="c85d4a5b-d0e9-432f-a177-26c4da8b7aa2" targetNamespace="http://schemas.microsoft.com/office/2006/metadata/properties" ma:root="true" ma:fieldsID="20fe1720e75618d275058a05dac76511" ns3:_="">
    <xsd:import namespace="c85d4a5b-d0e9-432f-a177-26c4da8b7aa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85d4a5b-d0e9-432f-a177-26c4da8b7aa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BF7D647-C122-42BB-AD83-47B074272A9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EF59171-AFA1-4514-8A52-1A6DEF70E44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85d4a5b-d0e9-432f-a177-26c4da8b7aa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B422C33-4D23-48A4-BA9A-F2A20CD84DF4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</TotalTime>
  <Words>105</Words>
  <Application>Microsoft Office PowerPoint</Application>
  <PresentationFormat>A4 Paper (210x297 mm)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dhisattwa Banerjee</dc:creator>
  <cp:lastModifiedBy>Bodhisattwa Banerjee</cp:lastModifiedBy>
  <cp:revision>2</cp:revision>
  <dcterms:created xsi:type="dcterms:W3CDTF">2020-07-07T12:57:34Z</dcterms:created>
  <dcterms:modified xsi:type="dcterms:W3CDTF">2020-10-21T11:4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C3B29FB5C0B9348989210E6C8B190A2</vt:lpwstr>
  </property>
</Properties>
</file>